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57" r:id="rId3"/>
    <p:sldId id="260" r:id="rId4"/>
    <p:sldId id="264" r:id="rId5"/>
    <p:sldId id="263" r:id="rId6"/>
    <p:sldId id="26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2" userDrawn="1">
          <p15:clr>
            <a:srgbClr val="A4A3A4"/>
          </p15:clr>
        </p15:guide>
        <p15:guide id="2" pos="15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535"/>
  </p:normalViewPr>
  <p:slideViewPr>
    <p:cSldViewPr snapToGrid="0">
      <p:cViewPr varScale="1">
        <p:scale>
          <a:sx n="90" d="100"/>
          <a:sy n="90" d="100"/>
        </p:scale>
        <p:origin x="232" y="296"/>
      </p:cViewPr>
      <p:guideLst>
        <p:guide orient="horz" pos="572"/>
        <p:guide pos="15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AC9673-4C53-723D-7FBE-7380AA7B6D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80F9442-12B9-DBF0-A050-20959AE905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7D0F40-1BB1-1A00-18E1-4F02A2BA2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66A4A5-B5A7-0B76-77C9-BA2252BFF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7C35C5-9D70-95E5-6ABB-26759D047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96513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C7AF8C-97EA-7DAF-B98E-21C9CBBF8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FB9D3E-A222-B89E-46EA-A97A9CA9B1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5E53B5-9A1B-D1C8-9C99-F189988CB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D5F3AD-AF8E-EA69-3BBD-8C9B783E7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B70290-E621-3298-F3F6-1A6E1E009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7010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B19D835-44AC-94DE-610A-49CF00885E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52D677-AECD-B880-0FF6-4317A66FC8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6887EB-EC57-729B-3B61-BE9F23CF6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AB1223-1565-7054-9C7D-19825950A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C95ED8-4BB8-D018-9F32-0708F2BFB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41208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CF28E0-BB02-A3BC-80AB-E67870BD8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1D6A10-2FA2-7FC7-4601-00583C1591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85161F-C341-1E06-8782-365B7F2D2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B6FF14-0458-9E50-DBFD-4FD568DFE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BD447A-3D44-EA5E-CB26-7BF134916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91243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E5CFAB-722D-2679-B5EE-5E0FB4207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B868FB-5FB3-F89D-4540-F63199DFCD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492C92-C9C1-B52E-909B-4801079D6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592D24-4108-9991-CA3E-56AFC500E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710B50-8076-8EA6-2898-166F28602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1242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19136F-9FCC-EA74-2CB1-B74C98D83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7EE954-2CAE-28D9-DB1E-EBBAB282A3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5ADC66-B898-4A33-012A-DE636794C0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C16D004-140F-2945-E071-C86832FD3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7A0768-1A8E-A0F0-87E5-7947690CF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708334-7CEB-E757-904C-A105D2F69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0268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D80DF7-B91A-A3AA-5AF9-8D1C9607C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0ACF05-BE28-66DC-8139-F09F060753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0D6D25C-6B90-24C4-D59D-BC9903A55C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3AD6C3-8500-4769-2F9E-3C2D3D48D6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A72DCD8-F1DB-F585-87EB-13313A3DBC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848FF9-F151-7837-4A23-23B57E2DC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90ABADC-296A-C233-028F-E5EFCAACF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B83F871-2092-C9DA-917B-518641FE3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5737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AF3D90-9D38-86CF-8324-D5E49B04F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ADF834F-71F3-B139-E49B-F279B926C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DEA2BDE-8FB7-2D11-9693-A9DC39B54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BC2ADAB-D726-6CA4-08D6-FFA46AC03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85976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730E562-4462-FE74-25D9-8C8B03C0F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84A6CBD-2CAA-F46B-2E66-1F2CF822D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E0DA588-32C9-865D-1E23-BF7C8196C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37093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B6B1E4-73F6-4389-F366-6710FA3E3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62FF55-B77C-38BF-B8FC-DE1225588C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B7460D-0E8D-C38B-8A77-FAEFFC920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0E9DB41-3A02-09FD-1914-F1B19B7F5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07A2CF-A737-63E6-3D97-5C04BAEF4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750AF7-E793-31B0-6E3E-C1548DAAE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36338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C29A91-33DA-D810-E9ED-74AD80BA3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02839BE-6C94-D71A-C871-4590CB997F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A5530D3-2488-B154-63ED-BD8983392A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784D23-E271-3DB3-E8C7-C581E91AE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0BA14A-AA78-9385-6F70-14011C758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A51462E-988D-7FF5-598D-300B7C934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40730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F76BA38-7CA8-5151-375A-F4D5B4DB6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CA847F-ACC6-88D9-1A39-E1F327880E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D8E08C-AF14-E2F5-A41F-279A01E5D7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EBC9C3-D05F-D844-BA90-2DFD06F4EA5E}" type="datetimeFigureOut">
              <a:rPr kumimoji="1" lang="zh-CN" altLang="en-US" smtClean="0"/>
              <a:t>2026/5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1C3832-6CBA-77A1-88C4-E443998C38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8E95A4-4C15-961E-E59A-67CC47FD3A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8353E5-BBBB-644B-BA0A-622D2BF5954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3891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F8EA32E-090A-56D1-22E1-4D35FC5484AC}"/>
              </a:ext>
            </a:extLst>
          </p:cNvPr>
          <p:cNvSpPr txBox="1"/>
          <p:nvPr/>
        </p:nvSpPr>
        <p:spPr>
          <a:xfrm>
            <a:off x="3327400" y="2032000"/>
            <a:ext cx="49600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 b="0" i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endParaRPr kumimoji="1"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2308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bc82a26f5565ccb3f788817c9e4c508c">
            <a:extLst>
              <a:ext uri="{FF2B5EF4-FFF2-40B4-BE49-F238E27FC236}">
                <a16:creationId xmlns:a16="http://schemas.microsoft.com/office/drawing/2014/main" id="{73B2E328-4459-93DC-1257-B32438571A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4269" y="1077282"/>
            <a:ext cx="2669540" cy="2643505"/>
          </a:xfrm>
          <a:prstGeom prst="rect">
            <a:avLst/>
          </a:prstGeom>
        </p:spPr>
      </p:pic>
      <p:pic>
        <p:nvPicPr>
          <p:cNvPr id="3" name="图片 2" descr="1a36d7d5d301f741ef7f9aa6577cd57f">
            <a:extLst>
              <a:ext uri="{FF2B5EF4-FFF2-40B4-BE49-F238E27FC236}">
                <a16:creationId xmlns:a16="http://schemas.microsoft.com/office/drawing/2014/main" id="{1ABEAB07-6534-5334-68AA-925DD90D25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5989" y="1077282"/>
            <a:ext cx="2780665" cy="264350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53A604E-D74A-2E91-0A74-F4364CC11BBF}"/>
              </a:ext>
            </a:extLst>
          </p:cNvPr>
          <p:cNvSpPr txBox="1"/>
          <p:nvPr/>
        </p:nvSpPr>
        <p:spPr>
          <a:xfrm>
            <a:off x="433137" y="4318187"/>
            <a:ext cx="116465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Comparison of fluorescence intensity under blue light irradiation.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Fluorescence intensity difference between </a:t>
            </a:r>
            <a:r>
              <a:rPr kumimoji="1"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1655 and </a:t>
            </a:r>
            <a:r>
              <a:rPr kumimoji="1"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G1655 (pAS102); (B) Fluorescence intensity difference between </a:t>
            </a:r>
            <a:r>
              <a:rPr kumimoji="1"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subtilis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8 and </a:t>
            </a:r>
            <a:r>
              <a:rPr kumimoji="1"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subtilis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8 (pAS102).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6314BBC-BAFF-9C78-8AAB-81A0C16FA869}"/>
              </a:ext>
            </a:extLst>
          </p:cNvPr>
          <p:cNvSpPr txBox="1"/>
          <p:nvPr/>
        </p:nvSpPr>
        <p:spPr>
          <a:xfrm>
            <a:off x="1456841" y="55793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EE1F0CC-0BCE-63AC-A743-F0EEF8FF3B9F}"/>
              </a:ext>
            </a:extLst>
          </p:cNvPr>
          <p:cNvSpPr txBox="1"/>
          <p:nvPr/>
        </p:nvSpPr>
        <p:spPr>
          <a:xfrm>
            <a:off x="5220345" y="554677"/>
            <a:ext cx="4520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3774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D88EC76-DC5F-58E9-7DEA-B455E02CE775}"/>
              </a:ext>
            </a:extLst>
          </p:cNvPr>
          <p:cNvSpPr txBox="1"/>
          <p:nvPr/>
        </p:nvSpPr>
        <p:spPr>
          <a:xfrm>
            <a:off x="2085473" y="38374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FBD9617-AE90-96EA-40BC-A8763638A6AE}"/>
              </a:ext>
            </a:extLst>
          </p:cNvPr>
          <p:cNvSpPr txBox="1"/>
          <p:nvPr/>
        </p:nvSpPr>
        <p:spPr>
          <a:xfrm>
            <a:off x="1981201" y="254267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A140B81-6839-DD23-7909-1FB1709D4C89}"/>
              </a:ext>
            </a:extLst>
          </p:cNvPr>
          <p:cNvSpPr txBox="1"/>
          <p:nvPr/>
        </p:nvSpPr>
        <p:spPr>
          <a:xfrm>
            <a:off x="1963567" y="476450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2960886-BDA8-04BF-812A-54898E387F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2957" y="0"/>
            <a:ext cx="6413500" cy="656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93615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AC7C82A-1F52-51BC-D13E-2B92587375E1}"/>
              </a:ext>
            </a:extLst>
          </p:cNvPr>
          <p:cNvSpPr txBox="1"/>
          <p:nvPr/>
        </p:nvSpPr>
        <p:spPr>
          <a:xfrm>
            <a:off x="469900" y="1117600"/>
            <a:ext cx="11252200" cy="333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2. PCR amplification and DNA gel electrophoresis analysis of transconjugant colonies from conjugation between 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lang="en-US" altLang="zh-CN" sz="18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changensis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EAU-ST10-9ᵀ and 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c102.</a:t>
            </a: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PCR amplification using primers 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apA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up and 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apA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down; (B) PCR amplification using primers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T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F and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T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R; (C) PCR amplification using primers 27F and 1492R. Lanes 1–22: PCR products of individual transconjugant colonies; Lane 23: PCR product with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c102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omic DNA as the template; Lane 24: PCR product with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changensis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EAU-ST10-9ᵀ genomic DNA as the template; Lane 25: DNA marker (5000 bp DNA ladder from Takara Bio</a:t>
            </a:r>
            <a:r>
              <a:rPr lang="zh-CN" altLang="en-US" sz="18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SA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Inc.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n Jose, CA,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SA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</a:t>
            </a:r>
            <a:endParaRPr lang="zh-CN" altLang="zh-CN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06088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AD4281C-28F8-0CD3-2099-120E5223D4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9915" y="0"/>
            <a:ext cx="5431485" cy="649825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3996F5A-086B-6157-2D1A-D812EA72E066}"/>
              </a:ext>
            </a:extLst>
          </p:cNvPr>
          <p:cNvSpPr txBox="1"/>
          <p:nvPr/>
        </p:nvSpPr>
        <p:spPr>
          <a:xfrm>
            <a:off x="2845364" y="6488668"/>
            <a:ext cx="573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e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103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.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60962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6FCEA13-65C7-D3BC-1F77-441822CF3718}"/>
              </a:ext>
            </a:extLst>
          </p:cNvPr>
          <p:cNvSpPr txBox="1"/>
          <p:nvPr/>
        </p:nvSpPr>
        <p:spPr>
          <a:xfrm>
            <a:off x="235527" y="5745621"/>
            <a:ext cx="12056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. S4. Pd</a:t>
            </a:r>
            <a:r>
              <a:rPr lang="en-US" altLang="zh-CN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103</a:t>
            </a: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treated maize seedlings observed via inverted fluorescence microscope at 1000× total magnification (10× eyepiece, 100× objective lens)</a:t>
            </a:r>
            <a:r>
              <a:rPr lang="en-US" altLang="zh-CN" sz="18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kumimoji="1" lang="zh-CN" altLang="en-US" dirty="0"/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id="{656707F9-D74D-7ADC-AB3C-E3A9E94DEFE3}"/>
              </a:ext>
            </a:extLst>
          </p:cNvPr>
          <p:cNvGrpSpPr/>
          <p:nvPr/>
        </p:nvGrpSpPr>
        <p:grpSpPr>
          <a:xfrm>
            <a:off x="3958441" y="238289"/>
            <a:ext cx="5578765" cy="5105400"/>
            <a:chOff x="6161314" y="349125"/>
            <a:chExt cx="5578765" cy="5105400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67251A5F-6CBE-7D6D-6A89-ECBB63896D76}"/>
                </a:ext>
              </a:extLst>
            </p:cNvPr>
            <p:cNvSpPr txBox="1"/>
            <p:nvPr/>
          </p:nvSpPr>
          <p:spPr>
            <a:xfrm>
              <a:off x="6161314" y="2503714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zh-CN" altLang="en-US" dirty="0"/>
            </a:p>
          </p:txBody>
        </p:sp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B3B6BC99-886C-33EC-9B56-A8641D62C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253679" y="349125"/>
              <a:ext cx="5486400" cy="5105400"/>
            </a:xfrm>
            <a:prstGeom prst="rect">
              <a:avLst/>
            </a:prstGeom>
          </p:spPr>
        </p:pic>
        <p:cxnSp>
          <p:nvCxnSpPr>
            <p:cNvPr id="6" name="直线箭头连接符 5">
              <a:extLst>
                <a:ext uri="{FF2B5EF4-FFF2-40B4-BE49-F238E27FC236}">
                  <a16:creationId xmlns:a16="http://schemas.microsoft.com/office/drawing/2014/main" id="{EA37DC59-D775-D007-DB1C-50CDB7DF3FC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481789" y="3366655"/>
              <a:ext cx="479629" cy="360218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C359DAC-E9CE-5B6B-CB14-C07130528666}"/>
                </a:ext>
              </a:extLst>
            </p:cNvPr>
            <p:cNvSpPr txBox="1"/>
            <p:nvPr/>
          </p:nvSpPr>
          <p:spPr>
            <a:xfrm>
              <a:off x="9876476" y="3548535"/>
              <a:ext cx="8098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10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06259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3</TotalTime>
  <Words>216</Words>
  <Application>Microsoft Macintosh PowerPoint</Application>
  <PresentationFormat>宽屏</PresentationFormat>
  <Paragraphs>11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</dc:creator>
  <cp:lastModifiedBy>Microsoft</cp:lastModifiedBy>
  <cp:revision>13</cp:revision>
  <dcterms:created xsi:type="dcterms:W3CDTF">2026-01-20T05:14:55Z</dcterms:created>
  <dcterms:modified xsi:type="dcterms:W3CDTF">2026-05-09T05:42:52Z</dcterms:modified>
</cp:coreProperties>
</file>